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59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93" autoAdjust="0"/>
    <p:restoredTop sz="94660"/>
  </p:normalViewPr>
  <p:slideViewPr>
    <p:cSldViewPr snapToGrid="0">
      <p:cViewPr varScale="1">
        <p:scale>
          <a:sx n="68" d="100"/>
          <a:sy n="68" d="100"/>
        </p:scale>
        <p:origin x="73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AD794F4-E24B-4C3A-8DE7-8644BA25239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88C3AD24-262E-48BC-A448-191201D62E2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3BA800E-ADA8-477B-BBFC-0A7F899F07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E49F798-FD2B-4130-ACB2-CCA3DC4B62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C38B6BB-288D-4171-BBDA-DBC99E46E3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883317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429BC7A-9904-4420-A177-0B4824DBF6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4F283BAE-8F74-410B-9C96-6E81A5ADDF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9A8226A-468B-4546-BA59-89A6AE4B9C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31E441E-A9B1-4774-BC4F-BBA3F67BA0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CB4BFE2-0F35-40C6-B2C3-D3D9A0705D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562708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55869236-FDC7-4D96-8AED-B5D7E7581F1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33B1EF50-7D2A-4748-B2F2-FC4D98C1705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3E807BD-4786-4C20-8062-8D30011E4A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E7DCFD0-A0D1-4347-BA44-13D9845723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ACFA070-029E-4735-BE88-D500ECF1CE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475126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4CB7339-993D-4FA5-983D-A25565452F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1B47DAD3-E5E8-4B77-90EE-85559A52A98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9B53BDF-81F5-4F8F-AFDF-5A6B4AA9FF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29D9C04-42B6-4127-9843-4FA0C6F186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B77C614B-1C4C-4D6D-A0D8-F1F0E90029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991894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90A6805-5391-4E95-9FE0-B47BF988E1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99AFC12C-9152-4F98-A17C-9BB4D51F80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70902CD-EFDF-4875-A521-8B4E3D0817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5727A39-7441-4A35-9BE0-EA2CC1AFE3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AC4AE2E-7F80-4136-9A9D-8495C05E62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602636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E3131A7-59FC-4143-AFB9-61D62FBD43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531187DF-B6CE-419F-8591-FEA7CB00774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6F17C53F-EEBA-44A4-93C4-45FE81163AB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B7F3DFA8-CF3D-439D-A4ED-78C2E8B4A7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5EE11231-4D9E-4E7E-BCD9-29E577E60F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678DBCEE-06D6-45E6-A437-9A13B38B5A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619379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01A5D13-433A-4C32-9377-E9E9CB814A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596B9F03-B5D8-4411-AF29-0D6DBB765C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A034E265-D882-4DF4-9616-C77492F73F5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9956D15D-844B-41D2-9C3C-C28AA875E6C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AE304CC8-348C-4DCE-9D90-43DADF4939F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C86BCF52-C358-43AA-9AF6-40F6D0FA0B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70C02941-E7D3-4F3A-818E-FBF43D25AE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F6C21B59-AC8C-4F42-BA4D-4BBDEDCC5F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183028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E2FCBAB-BD40-4C04-B815-B861D74745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FF55B1DB-BEA0-4D8A-8F3D-EFFDFA5EC1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23D4AA13-C723-47DD-AE5D-73E7DA4F33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72C6CC98-7162-4B63-9D10-73387AAD30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425054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5E06B809-293D-4A41-980C-41F6E8EC74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92783A2A-84E3-4E5D-BC51-18D66AE27D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03C0139A-BD26-4D58-BA2D-4C4FFB2E1A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99911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82F73F1-1F5E-47BE-9822-7E8D75CBF3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BCAA0D1B-CF27-4B03-819E-D30A047BDB0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F27CEC52-2772-4F6A-9ACB-4356295024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C39EC593-D518-4752-8BF9-36A51FC5E9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B1BF9124-C299-487E-87F0-5104F30273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E9D7E7BC-F925-4847-8636-7370A4F227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572932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7A4B86D-21AE-459A-B75D-444345B57A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54E9E3C4-9994-458F-B88B-3D1EB2F14B1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ED3254EA-5F8A-467F-ADC6-16F1533EEE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425A3CAB-D840-486C-9249-BEE944D01A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E007D05F-2401-4BE9-A2C9-29E32A6952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F8EC34F3-15C8-479A-90C6-70CE0D6469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553272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BB40E1D7-86FC-4335-BC71-47C3751E99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2FB86F34-1E8F-4059-B9E8-231681B13BC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C3D2838-EAC2-4351-93C6-833B3892586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096AB80-D735-4F56-B486-DFADE9AD984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0C81C39-724B-4D61-BD6A-9A3850C719A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76172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>
            <a:extLst>
              <a:ext uri="{FF2B5EF4-FFF2-40B4-BE49-F238E27FC236}">
                <a16:creationId xmlns:a16="http://schemas.microsoft.com/office/drawing/2014/main" id="{F9C959B3-64C4-45A3-B5D3-83EBEBB1F5D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82457" y="1057439"/>
            <a:ext cx="2442096" cy="1675317"/>
          </a:xfrm>
          <a:prstGeom prst="rect">
            <a:avLst/>
          </a:prstGeom>
        </p:spPr>
      </p:pic>
      <p:pic>
        <p:nvPicPr>
          <p:cNvPr id="3" name="그림 2">
            <a:extLst>
              <a:ext uri="{FF2B5EF4-FFF2-40B4-BE49-F238E27FC236}">
                <a16:creationId xmlns:a16="http://schemas.microsoft.com/office/drawing/2014/main" id="{567527A1-5FDF-4A83-ABC7-1549621D4B0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44757" y="1057439"/>
            <a:ext cx="2602371" cy="1675317"/>
          </a:xfrm>
          <a:prstGeom prst="rect">
            <a:avLst/>
          </a:prstGeom>
        </p:spPr>
      </p:pic>
      <p:pic>
        <p:nvPicPr>
          <p:cNvPr id="4" name="그림 3">
            <a:extLst>
              <a:ext uri="{FF2B5EF4-FFF2-40B4-BE49-F238E27FC236}">
                <a16:creationId xmlns:a16="http://schemas.microsoft.com/office/drawing/2014/main" id="{648C2309-4B96-405E-AF90-546A26382E3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96373" y="3681195"/>
            <a:ext cx="2600092" cy="167531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B6BD75AC-9633-44B5-8816-8DDBEBA1A96F}"/>
              </a:ext>
            </a:extLst>
          </p:cNvPr>
          <p:cNvSpPr txBox="1"/>
          <p:nvPr/>
        </p:nvSpPr>
        <p:spPr>
          <a:xfrm rot="16200000">
            <a:off x="1500636" y="1723755"/>
            <a:ext cx="15710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Half viability (days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8BBA26D-41C4-4A9D-9B3E-1CC132DD4F09}"/>
              </a:ext>
            </a:extLst>
          </p:cNvPr>
          <p:cNvSpPr txBox="1"/>
          <p:nvPr/>
        </p:nvSpPr>
        <p:spPr>
          <a:xfrm>
            <a:off x="3072445" y="2916079"/>
            <a:ext cx="142058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TRPV1 inhibitor</a:t>
            </a:r>
          </a:p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SB366791) (mM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BC1E5C1-7A9C-45CB-8D27-E6C4D27F28A6}"/>
              </a:ext>
            </a:extLst>
          </p:cNvPr>
          <p:cNvSpPr txBox="1"/>
          <p:nvPr/>
        </p:nvSpPr>
        <p:spPr>
          <a:xfrm>
            <a:off x="6584387" y="2893375"/>
            <a:ext cx="14430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Gabapentin (mM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4F18764-34D4-4FAB-B8AD-93811EFBD35A}"/>
              </a:ext>
            </a:extLst>
          </p:cNvPr>
          <p:cNvSpPr txBox="1"/>
          <p:nvPr/>
        </p:nvSpPr>
        <p:spPr>
          <a:xfrm>
            <a:off x="3072445" y="5547218"/>
            <a:ext cx="13067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Ibuprofen (mM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816D58B-8E57-4CAA-8304-E137320ADE11}"/>
              </a:ext>
            </a:extLst>
          </p:cNvPr>
          <p:cNvSpPr txBox="1"/>
          <p:nvPr/>
        </p:nvSpPr>
        <p:spPr>
          <a:xfrm rot="16200000">
            <a:off x="4764758" y="1711879"/>
            <a:ext cx="15710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Half viability (days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F8CA9CE-F271-48C2-80C6-5555A11EAF30}"/>
              </a:ext>
            </a:extLst>
          </p:cNvPr>
          <p:cNvSpPr txBox="1"/>
          <p:nvPr/>
        </p:nvSpPr>
        <p:spPr>
          <a:xfrm rot="16200000">
            <a:off x="1524388" y="4327766"/>
            <a:ext cx="15710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Half viability (days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F15AA45-FBB0-433A-98BA-239241212A47}"/>
              </a:ext>
            </a:extLst>
          </p:cNvPr>
          <p:cNvSpPr txBox="1"/>
          <p:nvPr/>
        </p:nvSpPr>
        <p:spPr>
          <a:xfrm rot="16200000">
            <a:off x="4849072" y="4351516"/>
            <a:ext cx="15710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Half viability (days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ACF3425-01CD-4D04-AB9F-205A3E7F73FC}"/>
              </a:ext>
            </a:extLst>
          </p:cNvPr>
          <p:cNvSpPr txBox="1"/>
          <p:nvPr/>
        </p:nvSpPr>
        <p:spPr>
          <a:xfrm>
            <a:off x="2395497" y="998817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0165DA3-C4EE-4F45-83B7-2D978E426543}"/>
              </a:ext>
            </a:extLst>
          </p:cNvPr>
          <p:cNvSpPr txBox="1"/>
          <p:nvPr/>
        </p:nvSpPr>
        <p:spPr>
          <a:xfrm>
            <a:off x="2395497" y="1372142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BA33046-C59F-4A1C-9C52-1F547ABA018C}"/>
              </a:ext>
            </a:extLst>
          </p:cNvPr>
          <p:cNvSpPr txBox="1"/>
          <p:nvPr/>
        </p:nvSpPr>
        <p:spPr>
          <a:xfrm>
            <a:off x="2395497" y="1737356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395075D-7DA6-4352-A2DA-D206660EDCC7}"/>
              </a:ext>
            </a:extLst>
          </p:cNvPr>
          <p:cNvSpPr txBox="1"/>
          <p:nvPr/>
        </p:nvSpPr>
        <p:spPr>
          <a:xfrm>
            <a:off x="2395497" y="211598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AC6E7C2-B052-4D4B-93D8-31192655C1BC}"/>
              </a:ext>
            </a:extLst>
          </p:cNvPr>
          <p:cNvSpPr txBox="1"/>
          <p:nvPr/>
        </p:nvSpPr>
        <p:spPr>
          <a:xfrm>
            <a:off x="2395497" y="2525456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DE6BEB7-F251-427A-BF0B-78A5CD04DA89}"/>
              </a:ext>
            </a:extLst>
          </p:cNvPr>
          <p:cNvSpPr txBox="1"/>
          <p:nvPr/>
        </p:nvSpPr>
        <p:spPr>
          <a:xfrm>
            <a:off x="2400752" y="362950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EF27ECC2-1D79-45B7-9622-AD21D403FA7A}"/>
              </a:ext>
            </a:extLst>
          </p:cNvPr>
          <p:cNvSpPr txBox="1"/>
          <p:nvPr/>
        </p:nvSpPr>
        <p:spPr>
          <a:xfrm>
            <a:off x="2400752" y="4002834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849E782-B67C-4AA7-8A21-478316C62D30}"/>
              </a:ext>
            </a:extLst>
          </p:cNvPr>
          <p:cNvSpPr txBox="1"/>
          <p:nvPr/>
        </p:nvSpPr>
        <p:spPr>
          <a:xfrm>
            <a:off x="2400752" y="438585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F67C492-8D9B-41EE-BA5B-9A196354012E}"/>
              </a:ext>
            </a:extLst>
          </p:cNvPr>
          <p:cNvSpPr txBox="1"/>
          <p:nvPr/>
        </p:nvSpPr>
        <p:spPr>
          <a:xfrm>
            <a:off x="2400752" y="474073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67DC3D8-74C4-4BFB-BDA4-573E34456BE7}"/>
              </a:ext>
            </a:extLst>
          </p:cNvPr>
          <p:cNvSpPr txBox="1"/>
          <p:nvPr/>
        </p:nvSpPr>
        <p:spPr>
          <a:xfrm>
            <a:off x="2400752" y="5162084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5EEFF34-73A0-43FE-9FA5-59AF012E4C76}"/>
              </a:ext>
            </a:extLst>
          </p:cNvPr>
          <p:cNvSpPr txBox="1"/>
          <p:nvPr/>
        </p:nvSpPr>
        <p:spPr>
          <a:xfrm>
            <a:off x="5643854" y="102921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8CEDEC51-3CE9-44AF-A1F2-1C089C6AC961}"/>
              </a:ext>
            </a:extLst>
          </p:cNvPr>
          <p:cNvSpPr txBox="1"/>
          <p:nvPr/>
        </p:nvSpPr>
        <p:spPr>
          <a:xfrm>
            <a:off x="5643854" y="137284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6B85EDF6-8F9A-4E32-BBC6-7F7475A34C2A}"/>
              </a:ext>
            </a:extLst>
          </p:cNvPr>
          <p:cNvSpPr txBox="1"/>
          <p:nvPr/>
        </p:nvSpPr>
        <p:spPr>
          <a:xfrm>
            <a:off x="5643854" y="1761814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1091519-22BE-4015-877B-7DB6EAB2EA78}"/>
              </a:ext>
            </a:extLst>
          </p:cNvPr>
          <p:cNvSpPr txBox="1"/>
          <p:nvPr/>
        </p:nvSpPr>
        <p:spPr>
          <a:xfrm>
            <a:off x="5643854" y="2116691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83F96B7F-72DC-4CCE-841B-B6CCFF61FA4D}"/>
              </a:ext>
            </a:extLst>
          </p:cNvPr>
          <p:cNvSpPr txBox="1"/>
          <p:nvPr/>
        </p:nvSpPr>
        <p:spPr>
          <a:xfrm>
            <a:off x="5643854" y="2514284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B0CAC379-6EB7-4302-B72E-7E823A48F9E1}"/>
              </a:ext>
            </a:extLst>
          </p:cNvPr>
          <p:cNvSpPr txBox="1"/>
          <p:nvPr/>
        </p:nvSpPr>
        <p:spPr>
          <a:xfrm>
            <a:off x="2536239" y="2669858"/>
            <a:ext cx="24064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0          1          2          3          4           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A9A7D515-17D0-427B-96EB-B69272E51FF5}"/>
              </a:ext>
            </a:extLst>
          </p:cNvPr>
          <p:cNvSpPr txBox="1"/>
          <p:nvPr/>
        </p:nvSpPr>
        <p:spPr>
          <a:xfrm>
            <a:off x="2531059" y="5300997"/>
            <a:ext cx="28296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0         10        20       30        40        50        60 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7006CB6B-7855-44ED-88DA-A3B3DF4FF937}"/>
              </a:ext>
            </a:extLst>
          </p:cNvPr>
          <p:cNvSpPr txBox="1"/>
          <p:nvPr/>
        </p:nvSpPr>
        <p:spPr>
          <a:xfrm>
            <a:off x="6513132" y="5547218"/>
            <a:ext cx="13724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Diclofenac (mM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051C05EB-A853-41C5-ACE5-1F6EFEB4ED5A}"/>
              </a:ext>
            </a:extLst>
          </p:cNvPr>
          <p:cNvSpPr txBox="1"/>
          <p:nvPr/>
        </p:nvSpPr>
        <p:spPr>
          <a:xfrm>
            <a:off x="5778077" y="2662543"/>
            <a:ext cx="25827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0           1           2           3           4           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 Box 20">
            <a:extLst>
              <a:ext uri="{FF2B5EF4-FFF2-40B4-BE49-F238E27FC236}">
                <a16:creationId xmlns:a16="http://schemas.microsoft.com/office/drawing/2014/main" id="{829E2AF1-0479-4AD2-9F2E-A8987BA3F3B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16729" y="237881"/>
            <a:ext cx="553357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latinLnBrk="0">
              <a:spcBef>
                <a:spcPct val="0"/>
              </a:spcBef>
              <a:buFontTx/>
              <a:buNone/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Fig S7</a:t>
            </a:r>
          </a:p>
        </p:txBody>
      </p:sp>
      <p:pic>
        <p:nvPicPr>
          <p:cNvPr id="40" name="그림 39">
            <a:extLst>
              <a:ext uri="{FF2B5EF4-FFF2-40B4-BE49-F238E27FC236}">
                <a16:creationId xmlns:a16="http://schemas.microsoft.com/office/drawing/2014/main" id="{84B16894-D312-4523-9F89-5CA723428C8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864238" y="3776273"/>
            <a:ext cx="2367452" cy="1595980"/>
          </a:xfrm>
          <a:prstGeom prst="rect">
            <a:avLst/>
          </a:prstGeom>
        </p:spPr>
      </p:pic>
      <p:sp>
        <p:nvSpPr>
          <p:cNvPr id="48" name="TextBox 47">
            <a:extLst>
              <a:ext uri="{FF2B5EF4-FFF2-40B4-BE49-F238E27FC236}">
                <a16:creationId xmlns:a16="http://schemas.microsoft.com/office/drawing/2014/main" id="{4304150C-B0F2-4D7D-A7A5-BB4CAA86BDE4}"/>
              </a:ext>
            </a:extLst>
          </p:cNvPr>
          <p:cNvSpPr txBox="1"/>
          <p:nvPr/>
        </p:nvSpPr>
        <p:spPr>
          <a:xfrm>
            <a:off x="5711898" y="370127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A598A077-1ADA-48F6-9DD2-E20F7C4BC01C}"/>
              </a:ext>
            </a:extLst>
          </p:cNvPr>
          <p:cNvSpPr txBox="1"/>
          <p:nvPr/>
        </p:nvSpPr>
        <p:spPr>
          <a:xfrm>
            <a:off x="5711898" y="4044914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DECA4D84-5ED2-43A7-83FE-9550B5C5719B}"/>
              </a:ext>
            </a:extLst>
          </p:cNvPr>
          <p:cNvSpPr txBox="1"/>
          <p:nvPr/>
        </p:nvSpPr>
        <p:spPr>
          <a:xfrm>
            <a:off x="5711898" y="4422004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1C5BDE43-23B8-4AB6-B664-B1040182081E}"/>
              </a:ext>
            </a:extLst>
          </p:cNvPr>
          <p:cNvSpPr txBox="1"/>
          <p:nvPr/>
        </p:nvSpPr>
        <p:spPr>
          <a:xfrm>
            <a:off x="5711898" y="4759067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B2A54DD7-2316-4343-BC63-D4F2900DDEAE}"/>
              </a:ext>
            </a:extLst>
          </p:cNvPr>
          <p:cNvSpPr txBox="1"/>
          <p:nvPr/>
        </p:nvSpPr>
        <p:spPr>
          <a:xfrm>
            <a:off x="5711898" y="511509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750DCB06-BBF6-4C88-A1E6-2AC5D50C3AE9}"/>
              </a:ext>
            </a:extLst>
          </p:cNvPr>
          <p:cNvSpPr txBox="1"/>
          <p:nvPr/>
        </p:nvSpPr>
        <p:spPr>
          <a:xfrm>
            <a:off x="5857311" y="5271309"/>
            <a:ext cx="24769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0       10       20      30      40       50      6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 Box 6">
            <a:extLst>
              <a:ext uri="{FF2B5EF4-FFF2-40B4-BE49-F238E27FC236}">
                <a16:creationId xmlns:a16="http://schemas.microsoft.com/office/drawing/2014/main" id="{962D9A37-F9D9-415D-A3C9-FF1E43B8C61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17439" y="341271"/>
            <a:ext cx="4219425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md-TRPV1(3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 fly viability on capsaicin-containing food</a:t>
            </a:r>
          </a:p>
          <a:p>
            <a:pPr algn="ct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with added analgesic drugs</a:t>
            </a:r>
          </a:p>
          <a:p>
            <a:pPr algn="ctr"/>
            <a:endParaRPr lang="en-US" altLang="ko-K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770033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37</TotalTime>
  <Words>100</Words>
  <Application>Microsoft Office PowerPoint</Application>
  <PresentationFormat>Widescreen</PresentationFormat>
  <Paragraphs>3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Saranya Siva</cp:lastModifiedBy>
  <cp:revision>149</cp:revision>
  <dcterms:created xsi:type="dcterms:W3CDTF">2022-10-18T02:31:52Z</dcterms:created>
  <dcterms:modified xsi:type="dcterms:W3CDTF">2023-02-08T08:36:09Z</dcterms:modified>
</cp:coreProperties>
</file>